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60" r:id="rId3"/>
    <p:sldId id="256" r:id="rId4"/>
    <p:sldId id="257" r:id="rId5"/>
    <p:sldId id="261" r:id="rId6"/>
    <p:sldId id="258" r:id="rId7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Guntinas Lichius, Orlando" initials="GLO" lastIdx="2" clrIdx="0">
    <p:extLst>
      <p:ext uri="{19B8F6BF-5375-455C-9EA6-DF929625EA0E}">
        <p15:presenceInfo xmlns:p15="http://schemas.microsoft.com/office/powerpoint/2012/main" userId="Guntinas Lichius, Orlando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202B0CA-FC54-4496-8BCA-5EF66A818D29}" styleName="Dunkle Formatvorlag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7E9639D4-E3E2-4D34-9284-5A2195B3D0D7}" styleName="Helle Formatvorlag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F2DE63D5-997A-4646-A377-4702673A728D}" styleName="Helle Formatvorlage 2 - Akz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>
        <p:scale>
          <a:sx n="100" d="100"/>
          <a:sy n="100" d="100"/>
        </p:scale>
        <p:origin x="1603" y="-32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BEC59A-B0C2-4E0F-800D-0C843142F1B3}" type="datetimeFigureOut">
              <a:rPr lang="de-DE" smtClean="0"/>
              <a:t>13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6DE4F-277A-457C-9FD3-CC5E6173132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2182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BEC59A-B0C2-4E0F-800D-0C843142F1B3}" type="datetimeFigureOut">
              <a:rPr lang="de-DE" smtClean="0"/>
              <a:t>13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6DE4F-277A-457C-9FD3-CC5E6173132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02180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BEC59A-B0C2-4E0F-800D-0C843142F1B3}" type="datetimeFigureOut">
              <a:rPr lang="de-DE" smtClean="0"/>
              <a:t>13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6DE4F-277A-457C-9FD3-CC5E6173132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37486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BEC59A-B0C2-4E0F-800D-0C843142F1B3}" type="datetimeFigureOut">
              <a:rPr lang="de-DE" smtClean="0"/>
              <a:t>13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6DE4F-277A-457C-9FD3-CC5E6173132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02346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BEC59A-B0C2-4E0F-800D-0C843142F1B3}" type="datetimeFigureOut">
              <a:rPr lang="de-DE" smtClean="0"/>
              <a:t>13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6DE4F-277A-457C-9FD3-CC5E6173132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824815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BEC59A-B0C2-4E0F-800D-0C843142F1B3}" type="datetimeFigureOut">
              <a:rPr lang="de-DE" smtClean="0"/>
              <a:t>13.02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6DE4F-277A-457C-9FD3-CC5E6173132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83649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BEC59A-B0C2-4E0F-800D-0C843142F1B3}" type="datetimeFigureOut">
              <a:rPr lang="de-DE" smtClean="0"/>
              <a:t>13.02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6DE4F-277A-457C-9FD3-CC5E6173132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039529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BEC59A-B0C2-4E0F-800D-0C843142F1B3}" type="datetimeFigureOut">
              <a:rPr lang="de-DE" smtClean="0"/>
              <a:t>13.02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6DE4F-277A-457C-9FD3-CC5E6173132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89287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BEC59A-B0C2-4E0F-800D-0C843142F1B3}" type="datetimeFigureOut">
              <a:rPr lang="de-DE" smtClean="0"/>
              <a:t>13.02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6DE4F-277A-457C-9FD3-CC5E6173132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307149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BEC59A-B0C2-4E0F-800D-0C843142F1B3}" type="datetimeFigureOut">
              <a:rPr lang="de-DE" smtClean="0"/>
              <a:t>13.02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6DE4F-277A-457C-9FD3-CC5E6173132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3435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BEC59A-B0C2-4E0F-800D-0C843142F1B3}" type="datetimeFigureOut">
              <a:rPr lang="de-DE" smtClean="0"/>
              <a:t>13.02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E6DE4F-277A-457C-9FD3-CC5E6173132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548981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BEC59A-B0C2-4E0F-800D-0C843142F1B3}" type="datetimeFigureOut">
              <a:rPr lang="de-DE" smtClean="0"/>
              <a:t>13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E6DE4F-277A-457C-9FD3-CC5E6173132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03307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14253" y="0"/>
            <a:ext cx="8681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Table S1: </a:t>
            </a: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4736" y="1680972"/>
            <a:ext cx="5748528" cy="88300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56887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4736" y="1594104"/>
            <a:ext cx="5748528" cy="90037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69634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47544730"/>
              </p:ext>
            </p:extLst>
          </p:nvPr>
        </p:nvGraphicFramePr>
        <p:xfrm>
          <a:off x="969579" y="504497"/>
          <a:ext cx="3901966" cy="276352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2896201">
                  <a:extLst>
                    <a:ext uri="{9D8B030D-6E8A-4147-A177-3AD203B41FA5}">
                      <a16:colId xmlns:a16="http://schemas.microsoft.com/office/drawing/2014/main" val="1430627679"/>
                    </a:ext>
                  </a:extLst>
                </a:gridCol>
                <a:gridCol w="1005765">
                  <a:extLst>
                    <a:ext uri="{9D8B030D-6E8A-4147-A177-3AD203B41FA5}">
                      <a16:colId xmlns:a16="http://schemas.microsoft.com/office/drawing/2014/main" val="3054522216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de-DE" sz="11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es</a:t>
                      </a:r>
                      <a:endParaRPr lang="de-DE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Fisher </a:t>
                      </a:r>
                      <a:r>
                        <a:rPr lang="de-DE" sz="11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st</a:t>
                      </a:r>
                      <a:endParaRPr lang="de-DE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4846036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1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. </a:t>
                      </a:r>
                      <a:r>
                        <a:rPr lang="de-DE" sz="11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reus</a:t>
                      </a:r>
                      <a:r>
                        <a:rPr lang="de-DE" sz="11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1293909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1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isseria</a:t>
                      </a:r>
                      <a:r>
                        <a:rPr lang="de-DE" sz="11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</a:t>
                      </a:r>
                      <a:r>
                        <a:rPr lang="de-DE" sz="11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2 *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4570649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1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phylococcus</a:t>
                      </a:r>
                      <a:r>
                        <a:rPr lang="de-DE" sz="11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ag</a:t>
                      </a:r>
                      <a:r>
                        <a:rPr lang="de-DE" sz="11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 Negative </a:t>
                      </a:r>
                    </a:p>
                    <a:p>
                      <a:endParaRPr lang="de-DE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9023186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1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ynebacterium</a:t>
                      </a:r>
                      <a:r>
                        <a:rPr lang="de-DE" sz="11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</a:t>
                      </a:r>
                      <a:r>
                        <a:rPr lang="de-DE" sz="11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		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516150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1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eptococcus</a:t>
                      </a:r>
                      <a:r>
                        <a:rPr lang="de-DE" sz="11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</a:t>
                      </a:r>
                      <a:r>
                        <a:rPr lang="de-DE" sz="11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7383309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1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terobacteriaceae</a:t>
                      </a:r>
                      <a:endParaRPr lang="de-DE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de-DE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97677564"/>
                  </a:ext>
                </a:extLst>
              </a:tr>
            </a:tbl>
          </a:graphicData>
        </a:graphic>
      </p:graphicFrame>
      <p:sp>
        <p:nvSpPr>
          <p:cNvPr id="5" name="Textfeld 4"/>
          <p:cNvSpPr txBox="1"/>
          <p:nvPr/>
        </p:nvSpPr>
        <p:spPr>
          <a:xfrm>
            <a:off x="14253" y="0"/>
            <a:ext cx="781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Table S2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14253" y="6721280"/>
            <a:ext cx="781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Table S3</a:t>
            </a:r>
          </a:p>
        </p:txBody>
      </p:sp>
      <p:graphicFrame>
        <p:nvGraphicFramePr>
          <p:cNvPr id="3" name="Tabel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47040130"/>
              </p:ext>
            </p:extLst>
          </p:nvPr>
        </p:nvGraphicFramePr>
        <p:xfrm>
          <a:off x="1307443" y="6998279"/>
          <a:ext cx="2791591" cy="4226767"/>
        </p:xfrm>
        <a:graphic>
          <a:graphicData uri="http://schemas.openxmlformats.org/drawingml/2006/table">
            <a:tbl>
              <a:tblPr firstRow="1">
                <a:tableStyleId>{F2DE63D5-997A-4646-A377-4702673A728D}</a:tableStyleId>
              </a:tblPr>
              <a:tblGrid>
                <a:gridCol w="1577647">
                  <a:extLst>
                    <a:ext uri="{9D8B030D-6E8A-4147-A177-3AD203B41FA5}">
                      <a16:colId xmlns:a16="http://schemas.microsoft.com/office/drawing/2014/main" val="3206694360"/>
                    </a:ext>
                  </a:extLst>
                </a:gridCol>
                <a:gridCol w="583324">
                  <a:extLst>
                    <a:ext uri="{9D8B030D-6E8A-4147-A177-3AD203B41FA5}">
                      <a16:colId xmlns:a16="http://schemas.microsoft.com/office/drawing/2014/main" val="3299191365"/>
                    </a:ext>
                  </a:extLst>
                </a:gridCol>
                <a:gridCol w="630620">
                  <a:extLst>
                    <a:ext uri="{9D8B030D-6E8A-4147-A177-3AD203B41FA5}">
                      <a16:colId xmlns:a16="http://schemas.microsoft.com/office/drawing/2014/main" val="3771578391"/>
                    </a:ext>
                  </a:extLst>
                </a:gridCol>
              </a:tblGrid>
              <a:tr h="22275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us</a:t>
                      </a:r>
                      <a:endParaRPr lang="de-DE" sz="1100" b="1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ease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93369829"/>
                  </a:ext>
                </a:extLst>
              </a:tr>
              <a:tr h="22275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oprevotella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DE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55409553"/>
                  </a:ext>
                </a:extLst>
              </a:tr>
              <a:tr h="22275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opobium sp.</a:t>
                      </a:r>
                      <a:endParaRPr lang="de-DE" sz="11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81276167"/>
                  </a:ext>
                </a:extLst>
              </a:tr>
              <a:tr h="234235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ynebacterium sp.</a:t>
                      </a:r>
                      <a:endParaRPr lang="de-DE" sz="11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3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5421018"/>
                  </a:ext>
                </a:extLst>
              </a:tr>
              <a:tr h="22275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losigranulum sp.</a:t>
                      </a:r>
                      <a:endParaRPr lang="de-DE" sz="11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8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45171694"/>
                  </a:ext>
                </a:extLst>
              </a:tr>
              <a:tr h="22275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cherichia sp.</a:t>
                      </a:r>
                      <a:endParaRPr lang="de-DE" sz="11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58220824"/>
                  </a:ext>
                </a:extLst>
              </a:tr>
              <a:tr h="22275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sobacterium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DE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10476096"/>
                  </a:ext>
                </a:extLst>
              </a:tr>
              <a:tr h="22275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emophilus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DE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30118926"/>
                  </a:ext>
                </a:extLst>
              </a:tr>
              <a:tr h="22275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rocoleus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DE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31705627"/>
                  </a:ext>
                </a:extLst>
              </a:tr>
              <a:tr h="22275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raxella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DE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87447847"/>
                  </a:ext>
                </a:extLst>
              </a:tr>
              <a:tr h="22275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vimonas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DE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77309069"/>
                  </a:ext>
                </a:extLst>
              </a:tr>
              <a:tr h="22275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ctobacterium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DE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5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7837073"/>
                  </a:ext>
                </a:extLst>
              </a:tr>
              <a:tr h="22275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ptoniphilus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DE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58702719"/>
                  </a:ext>
                </a:extLst>
              </a:tr>
              <a:tr h="217340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ptostreptococcus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DE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66720723"/>
                  </a:ext>
                </a:extLst>
              </a:tr>
              <a:tr h="22275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rphyromonas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DE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83574459"/>
                  </a:ext>
                </a:extLst>
              </a:tr>
              <a:tr h="22275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votella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DE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6095514"/>
                  </a:ext>
                </a:extLst>
              </a:tr>
              <a:tr h="211160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pionibacterium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DE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8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9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2246285"/>
                  </a:ext>
                </a:extLst>
              </a:tr>
              <a:tr h="22275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phylococcus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</a:t>
                      </a:r>
                      <a:r>
                        <a:rPr lang="de-DE" sz="11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.</a:t>
                      </a:r>
                      <a:endParaRPr lang="de-DE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.5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7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07450513"/>
                  </a:ext>
                </a:extLst>
              </a:tr>
              <a:tr h="222752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</a:t>
                      </a:r>
                      <a:endParaRPr lang="de-DE" sz="11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38192043"/>
                  </a:ext>
                </a:extLst>
              </a:tr>
            </a:tbl>
          </a:graphicData>
        </a:graphic>
      </p:graphicFrame>
      <p:sp>
        <p:nvSpPr>
          <p:cNvPr id="7" name="Textfeld 6"/>
          <p:cNvSpPr txBox="1"/>
          <p:nvPr/>
        </p:nvSpPr>
        <p:spPr>
          <a:xfrm>
            <a:off x="261404" y="40990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6" name="Tabel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56778733"/>
              </p:ext>
            </p:extLst>
          </p:nvPr>
        </p:nvGraphicFramePr>
        <p:xfrm>
          <a:off x="969579" y="4020628"/>
          <a:ext cx="3852000" cy="128016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303523">
                  <a:extLst>
                    <a:ext uri="{9D8B030D-6E8A-4147-A177-3AD203B41FA5}">
                      <a16:colId xmlns:a16="http://schemas.microsoft.com/office/drawing/2014/main" val="1039787045"/>
                    </a:ext>
                  </a:extLst>
                </a:gridCol>
                <a:gridCol w="1264477">
                  <a:extLst>
                    <a:ext uri="{9D8B030D-6E8A-4147-A177-3AD203B41FA5}">
                      <a16:colId xmlns:a16="http://schemas.microsoft.com/office/drawing/2014/main" val="3713780690"/>
                    </a:ext>
                  </a:extLst>
                </a:gridCol>
                <a:gridCol w="1284000">
                  <a:extLst>
                    <a:ext uri="{9D8B030D-6E8A-4147-A177-3AD203B41FA5}">
                      <a16:colId xmlns:a16="http://schemas.microsoft.com/office/drawing/2014/main" val="3964491807"/>
                    </a:ext>
                  </a:extLst>
                </a:gridCol>
              </a:tblGrid>
              <a:tr h="251507">
                <a:tc>
                  <a:txBody>
                    <a:bodyPr/>
                    <a:lstStyle/>
                    <a:p>
                      <a:pPr algn="ctr"/>
                      <a:endParaRPr lang="de-DE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s w/ ATB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s w/o ATB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04953237"/>
                  </a:ext>
                </a:extLst>
              </a:tr>
              <a:tr h="414247">
                <a:tc>
                  <a:txBody>
                    <a:bodyPr/>
                    <a:lstStyle/>
                    <a:p>
                      <a:pPr algn="ctr"/>
                      <a:r>
                        <a:rPr lang="de-DE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s w/</a:t>
                      </a:r>
                      <a:r>
                        <a:rPr lang="de-DE" sz="11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isseria</a:t>
                      </a:r>
                      <a:r>
                        <a:rPr lang="de-DE" sz="11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1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</a:t>
                      </a:r>
                      <a:r>
                        <a:rPr lang="de-DE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lang="de-DE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08228134"/>
                  </a:ext>
                </a:extLst>
              </a:tr>
              <a:tr h="414247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1100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s w/o </a:t>
                      </a:r>
                      <a:r>
                        <a:rPr kumimoji="0" lang="de-DE" sz="1100" i="1" u="none" strike="noStrike" kern="1200" cap="none" spc="0" normalizeH="0" baseline="0" noProof="0" dirty="0" err="1">
                          <a:ln>
                            <a:noFill/>
                          </a:ln>
                          <a:effectLst/>
                          <a:uLnTx/>
                          <a:uFillTx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isseria</a:t>
                      </a:r>
                      <a:r>
                        <a:rPr kumimoji="0" lang="de-DE" sz="1100" i="1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0" lang="de-DE" sz="1100" i="1" u="none" strike="noStrike" kern="1200" cap="none" spc="0" normalizeH="0" baseline="0" noProof="0" dirty="0" err="1">
                          <a:ln>
                            <a:noFill/>
                          </a:ln>
                          <a:effectLst/>
                          <a:uLnTx/>
                          <a:uFillTx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</a:t>
                      </a:r>
                      <a:r>
                        <a:rPr kumimoji="0" lang="de-DE" sz="1100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  <a:endParaRPr kumimoji="0" lang="de-DE" sz="1100" b="0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49555951"/>
                  </a:ext>
                </a:extLst>
              </a:tr>
            </a:tbl>
          </a:graphicData>
        </a:graphic>
      </p:graphicFrame>
      <p:sp>
        <p:nvSpPr>
          <p:cNvPr id="9" name="Textfeld 8"/>
          <p:cNvSpPr txBox="1"/>
          <p:nvPr/>
        </p:nvSpPr>
        <p:spPr>
          <a:xfrm>
            <a:off x="305569" y="374362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888275" y="5364480"/>
            <a:ext cx="12362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i="1" dirty="0">
                <a:latin typeface="Arial" panose="020B0604020202020204" pitchFamily="34" charset="0"/>
                <a:cs typeface="Arial" panose="020B0604020202020204" pitchFamily="34" charset="0"/>
              </a:rPr>
              <a:t>Fisher </a:t>
            </a:r>
            <a:r>
              <a:rPr lang="de-DE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test</a:t>
            </a:r>
            <a:r>
              <a:rPr lang="de-DE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&gt;0.99</a:t>
            </a:r>
          </a:p>
        </p:txBody>
      </p:sp>
    </p:spTree>
    <p:extLst>
      <p:ext uri="{BB962C8B-B14F-4D97-AF65-F5344CB8AC3E}">
        <p14:creationId xmlns:p14="http://schemas.microsoft.com/office/powerpoint/2010/main" val="12928346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8791" y="463363"/>
            <a:ext cx="4875429" cy="2709669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246491" y="94031"/>
            <a:ext cx="7970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u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S1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256997" y="3273403"/>
            <a:ext cx="21980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Figure S2: alpha diversity metric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344521" y="8137537"/>
            <a:ext cx="41328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u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S3: beta diversity metric.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ary-curti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imilarit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p=0.2</a:t>
            </a:r>
          </a:p>
        </p:txBody>
      </p:sp>
      <p:pic>
        <p:nvPicPr>
          <p:cNvPr id="7" name="Picture 6" descr="Chart, box and whisker chart&#10;&#10;Description automatically generated">
            <a:extLst>
              <a:ext uri="{FF2B5EF4-FFF2-40B4-BE49-F238E27FC236}">
                <a16:creationId xmlns:a16="http://schemas.microsoft.com/office/drawing/2014/main" id="{1DACCEB5-F419-44B8-9E39-924E75B85B5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032" y="3603969"/>
            <a:ext cx="5398019" cy="3599695"/>
          </a:xfrm>
          <a:prstGeom prst="rect">
            <a:avLst/>
          </a:prstGeom>
        </p:spPr>
      </p:pic>
      <p:pic>
        <p:nvPicPr>
          <p:cNvPr id="18" name="Picture 17" descr="Chart, scatter chart&#10;&#10;Description automatically generated">
            <a:extLst>
              <a:ext uri="{FF2B5EF4-FFF2-40B4-BE49-F238E27FC236}">
                <a16:creationId xmlns:a16="http://schemas.microsoft.com/office/drawing/2014/main" id="{3446BBB5-00CD-4B8E-AB91-B48391471663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997" y="8785553"/>
            <a:ext cx="4884007" cy="29284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96156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451201" y="471817"/>
            <a:ext cx="17059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Figure S4: CAMP Assay</a:t>
            </a: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-869233" y="2819400"/>
            <a:ext cx="6520707" cy="30482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43210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423349" y="648917"/>
            <a:ext cx="25587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Figure S5: Seahorse of bacteria alone</a:t>
            </a:r>
          </a:p>
        </p:txBody>
      </p:sp>
      <p:sp>
        <p:nvSpPr>
          <p:cNvPr id="4" name="Textfeld 3"/>
          <p:cNvSpPr txBox="1"/>
          <p:nvPr/>
        </p:nvSpPr>
        <p:spPr>
          <a:xfrm>
            <a:off x="292721" y="4668745"/>
            <a:ext cx="6264834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100" b="1" dirty="0">
                <a:latin typeface="Arial" panose="020B0604020202020204" pitchFamily="34" charset="0"/>
                <a:cs typeface="Arial" panose="020B0604020202020204" pitchFamily="34" charset="0"/>
              </a:rPr>
              <a:t>Table S4: Statistical comparison of Seahorse cell metabolic assay</a:t>
            </a:r>
          </a:p>
          <a:p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Statistical significances in the assay are compared to PBS alone and between the strains by two-way ANOVA. *p&lt;0.05; **p&lt;0.01; ***p&lt;0.001; ****p&lt;0.0001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380484" y="5268909"/>
            <a:ext cx="297389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100" dirty="0">
                <a:latin typeface="Arial" panose="020B0604020202020204" pitchFamily="34" charset="0"/>
                <a:cs typeface="Arial" panose="020B0604020202020204" pitchFamily="34" charset="0"/>
              </a:rPr>
              <a:t>A- Differences between each strain and PBS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423349" y="8756692"/>
            <a:ext cx="36695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B-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ifference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train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CRS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train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9" name="Grafik 8">
            <a:extLst>
              <a:ext uri="{FF2B5EF4-FFF2-40B4-BE49-F238E27FC236}">
                <a16:creationId xmlns:a16="http://schemas.microsoft.com/office/drawing/2014/main" id="{26D8B37D-9A12-3285-2411-730A0BD4576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7612" y="5798922"/>
            <a:ext cx="6202775" cy="2248340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61CCF855-054E-A87C-A26E-6F96FFFB5E8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0486" y="9144000"/>
            <a:ext cx="4713503" cy="2253996"/>
          </a:xfrm>
          <a:prstGeom prst="rect">
            <a:avLst/>
          </a:prstGeom>
        </p:spPr>
      </p:pic>
      <p:graphicFrame>
        <p:nvGraphicFramePr>
          <p:cNvPr id="11" name="Objekt 10">
            <a:extLst>
              <a:ext uri="{FF2B5EF4-FFF2-40B4-BE49-F238E27FC236}">
                <a16:creationId xmlns:a16="http://schemas.microsoft.com/office/drawing/2014/main" id="{49B5BA8F-41F0-E17B-C731-BF90A570FE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44706106"/>
              </p:ext>
            </p:extLst>
          </p:nvPr>
        </p:nvGraphicFramePr>
        <p:xfrm>
          <a:off x="542781" y="866894"/>
          <a:ext cx="4968875" cy="32718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969169" imgH="3271691" progId="Prism9.Document">
                  <p:embed/>
                </p:oleObj>
              </mc:Choice>
              <mc:Fallback>
                <p:oleObj name="Prism 9" r:id="rId4" imgW="4969169" imgH="3271691" progId="Prism9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9C22E265-B0A1-C007-A0ED-AAEB53A5C68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42781" y="866894"/>
                        <a:ext cx="4968875" cy="32718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9609475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257</Words>
  <Application>Microsoft Office PowerPoint</Application>
  <PresentationFormat>Widescreen</PresentationFormat>
  <Paragraphs>94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Offic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ätsklinikum Je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uchscherr de Hauschopp, Lorena</dc:creator>
  <cp:lastModifiedBy>MDPI</cp:lastModifiedBy>
  <cp:revision>33</cp:revision>
  <dcterms:created xsi:type="dcterms:W3CDTF">2022-09-13T10:34:56Z</dcterms:created>
  <dcterms:modified xsi:type="dcterms:W3CDTF">2024-02-13T09:00:05Z</dcterms:modified>
</cp:coreProperties>
</file>